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9705628-EA53-4568-A761-5EDC45174244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617040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731200"/>
            <a:ext cx="617040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06B3CAD-5A58-454C-9395-245E954A2A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31732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73120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73120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D8EBEF9-F3E2-446A-848F-241DE432DF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198648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317320"/>
            <a:ext cx="198648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317320"/>
            <a:ext cx="198648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731200"/>
            <a:ext cx="198648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731200"/>
            <a:ext cx="198648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731200"/>
            <a:ext cx="198648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15D1D99-70A3-4C47-BA3F-973CE5670AF8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317320"/>
            <a:ext cx="6170400" cy="653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C2E2333-365C-49B0-B815-514891FD5A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6170400" cy="653580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699BA18-2A06-4F8C-8E76-D18C89FDC3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3011040" cy="653580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317320"/>
            <a:ext cx="3011040" cy="653580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15F2833-985D-4EB3-B40B-0919E0DA31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53A61BD-29CA-46F1-B930-50E53BE4ED9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1620720"/>
            <a:ext cx="5827680" cy="15977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9829313-6121-41C7-846C-61A3B08E226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317320"/>
            <a:ext cx="3011040" cy="653580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73120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751320F-9BA8-4FD2-B87A-214BDDBC1E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3011040" cy="653580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31732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73120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F5037DB-19D7-446D-AAA8-E6C93B978D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31732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317320"/>
            <a:ext cx="301104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731200"/>
            <a:ext cx="6170400" cy="311724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0F7975A-C97A-40A6-BA45-8F9F5742E8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1620720"/>
            <a:ext cx="5827680" cy="3446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 idx="1"/>
          </p:nvPr>
        </p:nvSpPr>
        <p:spPr>
          <a:xfrm>
            <a:off x="471600" y="9181800"/>
            <a:ext cx="1541520" cy="52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  <a:defRPr b="0" lang="en-PH" sz="14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0" lang="en-PH" sz="1400" spc="-1" strike="noStrike">
                <a:solidFill>
                  <a:srgbClr val="000000"/>
                </a:solidFill>
                <a:latin typeface="Calibri"/>
                <a:ea typeface="Arial Unicode MS"/>
              </a:rPr>
              <a:t>9/15/1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sldNum" idx="2"/>
          </p:nvPr>
        </p:nvSpPr>
        <p:spPr>
          <a:xfrm>
            <a:off x="4843440" y="9181800"/>
            <a:ext cx="1541520" cy="52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  <a:defRPr b="0" lang="en-PH" sz="14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fld id="{2399DA26-4367-4C06-AAA1-1FE104C0C036}" type="slidenum">
              <a:rPr b="0" lang="en-PH" sz="14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343080" y="2317320"/>
            <a:ext cx="6170400" cy="6535800"/>
          </a:xfrm>
          <a:prstGeom prst="rect">
            <a:avLst/>
          </a:prstGeom>
          <a:noFill/>
          <a:ln w="0">
            <a:noFill/>
          </a:ln>
        </p:spPr>
        <p:txBody>
          <a:bodyPr lIns="0" rIns="0" tIns="2124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747880" y="592200"/>
            <a:ext cx="1096920" cy="639000"/>
          </a:xfrm>
          <a:prstGeom prst="rect">
            <a:avLst/>
          </a:prstGeom>
          <a:noFill/>
          <a:ln w="31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Animals issued and allocated to groups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61)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6 weeks old, male FVB/N mic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4065480" y="1166760"/>
            <a:ext cx="779400" cy="36468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Excluded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297240" y="1325520"/>
            <a:ext cx="76212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96920" y="1755720"/>
            <a:ext cx="1547640" cy="45612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Allocated to WT Vehicle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ceived allocated interventi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id not receive allocated interventi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506760" y="1751040"/>
            <a:ext cx="1548000" cy="45612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Allocated to Akita Vehicle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8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ceived allocated interventi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8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id not receive allocated interventi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852560" y="1755720"/>
            <a:ext cx="1548000" cy="45612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Allocated to WT MitoGamide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5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ceived allocated interventi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5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id not receive allocated interventi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162400" y="1751040"/>
            <a:ext cx="1548000" cy="45612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Allocated to Akita MitoGamide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ceived allocated interventi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id not receive allocated interventi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96920" y="2371680"/>
            <a:ext cx="1547640" cy="27324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iscontinued interventi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852560" y="2371680"/>
            <a:ext cx="1548000" cy="27324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iscontinued interventi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162400" y="2371680"/>
            <a:ext cx="1548000" cy="27324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iscontinued interventi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n=2 euthanised due to diabetic complication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506760" y="2371680"/>
            <a:ext cx="1548000" cy="27324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iscontinued interventi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n=4 euthanised due to diabetic complication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960480" y="1579680"/>
            <a:ext cx="1440" cy="16164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619360" y="1571760"/>
            <a:ext cx="1440" cy="16164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281480" y="1579680"/>
            <a:ext cx="1440" cy="16164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956200" y="1574640"/>
            <a:ext cx="1800" cy="1620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954000" y="1582560"/>
            <a:ext cx="500400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297240" y="1130400"/>
            <a:ext cx="1440" cy="4460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96920" y="2811600"/>
            <a:ext cx="1547640" cy="18180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Animals at endpoint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852560" y="2811600"/>
            <a:ext cx="1548000" cy="18180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Animals at endpoint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5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506760" y="2811600"/>
            <a:ext cx="1548000" cy="18180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Animals at endpoint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162400" y="2811600"/>
            <a:ext cx="1548000" cy="18180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Animals at endpoint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960480" y="2193840"/>
            <a:ext cx="1440" cy="1620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619360" y="2193840"/>
            <a:ext cx="1440" cy="1620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281480" y="2193840"/>
            <a:ext cx="1440" cy="1620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956200" y="2193840"/>
            <a:ext cx="1800" cy="1620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960480" y="2638440"/>
            <a:ext cx="1440" cy="1620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619360" y="2638440"/>
            <a:ext cx="1440" cy="1620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281480" y="2638440"/>
            <a:ext cx="1440" cy="1620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5956200" y="2638440"/>
            <a:ext cx="1800" cy="1620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96920" y="3159000"/>
            <a:ext cx="1547640" cy="383940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body, organ weight and blood glucose measurements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HbA1C measurements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8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Smaller number of samples measured for logistical reasons.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plasma insulin measurements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9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Smaller number of samples measured for logistical reasons.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echocardiography measurements: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 (n=1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: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 One batch of mice did not undergo echocardiography due to core facility scheduling issues (n=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reported for M-mode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for M-mode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reported for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for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: Heart rate &lt;300bpm (n=1) or &gt;500bpm (n=1) - no E/A wave separation.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reported for tissue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for tissue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960480" y="2981160"/>
            <a:ext cx="1440" cy="1620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619360" y="2981160"/>
            <a:ext cx="1440" cy="1620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281480" y="2981160"/>
            <a:ext cx="1440" cy="1620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5956200" y="2981160"/>
            <a:ext cx="1800" cy="1620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852560" y="3159000"/>
            <a:ext cx="1548000" cy="383940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body, organ weight and blood glucose measurements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5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HbA1C measurements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9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Smaller number of samples measured for logistical reasons.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plasma insulin measurements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Smaller number of samples measured for logistical reasons.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echocardiography measurements: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 (n=13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: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 One batch of mice did not undergo echocardiography due to core facility scheduling issues (n=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reported for M-mode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3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for M-mode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reported for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3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for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tissue Doppler echocardiography measurements: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 (n=13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for tissue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506760" y="3159000"/>
            <a:ext cx="1548000" cy="393084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body, organ weight and blood glucose measurements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HbA1C measurements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plasma insulin measurements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Smaller number of samples measured for logistical reasons.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echocardiography measurements: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 (n=9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s: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 One batch of mice did not undergo echocardiography due to core facility scheduling issues (n=2) Three mice in three separate experiments did not respond to anaesthetic and did not undergo echocardiography at operator’s discretion (n=3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reported for M-mode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9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for M-mode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reported for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7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for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No E/A wave separation (n=1) and extreme outlier identified as Q3+3*IQR (n=1).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reported for tissue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7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for tissue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: Heart rate &gt;450bpm – no e’/a’wave separation (n=1). Variable image/measurements (n=1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5162400" y="3159000"/>
            <a:ext cx="1548000" cy="3839400"/>
          </a:xfrm>
          <a:prstGeom prst="rect">
            <a:avLst/>
          </a:pr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body, organ weight and blood glucose measurements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HbA1C measurements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plasma insulin measurements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: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Smaller number of samples measured for logistical reasons.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Included in echocardiography measurements: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 (n=1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: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 One batch of mice did not undergo echocardiography due to core facility scheduling issues (n=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reported for M-mode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for M-mode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reported for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9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for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1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: Heart rate &lt;300bpm (n=1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reported for tissue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8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Data not reported for tissue Doppler echocardiography 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(n=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600" spc="-1" strike="noStrike">
                <a:solidFill>
                  <a:srgbClr val="000000"/>
                </a:solidFill>
                <a:latin typeface="Calibri"/>
              </a:rPr>
              <a:t>Reason</a:t>
            </a:r>
            <a:r>
              <a:rPr b="0" lang="en-PH" sz="600" spc="-1" strike="noStrike">
                <a:solidFill>
                  <a:srgbClr val="000000"/>
                </a:solidFill>
                <a:latin typeface="Calibri"/>
              </a:rPr>
              <a:t>: Heart rate &lt;250bpm (n=1) or &gt;450bpm – no e’/a’ wave separation (n=1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01320" y="12600"/>
            <a:ext cx="2210760" cy="30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PH" sz="14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dcterms:modified xsi:type="dcterms:W3CDTF">2019-09-14T17:50:10Z</dcterms:modified>
  <cp:revision>0</cp:revision>
  <dc:subject/>
  <dc:title/>
</cp:coreProperties>
</file>